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58" r:id="rId3"/>
    <p:sldId id="259" r:id="rId4"/>
    <p:sldId id="260" r:id="rId5"/>
    <p:sldId id="263" r:id="rId6"/>
    <p:sldId id="264" r:id="rId7"/>
    <p:sldId id="266" r:id="rId8"/>
    <p:sldId id="265" r:id="rId9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55" d="100"/>
          <a:sy n="55" d="100"/>
        </p:scale>
        <p:origin x="2640" y="4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C2CE0B-3658-EFD2-08CA-7DDF8DAA6D2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098FE78-8467-764A-2DD2-B3071911B4C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E4766E-C411-AD35-CB54-1535D872AC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8E381-F2BA-4A1F-AD30-CA17B4A5A7D3}" type="datetimeFigureOut">
              <a:rPr lang="en-GB" smtClean="0"/>
              <a:t>28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320C03-0259-7B9F-030A-0BC5D7961A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1C1EA3-E1D2-6448-FE6F-2A7E149476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CF57C-8BFD-45D9-A464-2FD639ACAE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15565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C8AB2C-02A8-34FB-272F-A102C02DBC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654B0E0-3E4F-81B1-8F6B-CAAEF3D127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C92111-6C69-7BAE-EAE9-4367C39420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8E381-F2BA-4A1F-AD30-CA17B4A5A7D3}" type="datetimeFigureOut">
              <a:rPr lang="en-GB" smtClean="0"/>
              <a:t>28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0069E8-845E-28E0-65BF-9950189DE7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006853-754E-8FCD-4096-7DA4CCF17E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CF57C-8BFD-45D9-A464-2FD639ACAE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97279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FCE0FDE-B753-01E7-3332-1A7FFA1C914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F2A700C-D535-0573-B3C9-6FBF6C0FA7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3A6DBD-16F1-CFA9-57E7-EDF6717CC1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8E381-F2BA-4A1F-AD30-CA17B4A5A7D3}" type="datetimeFigureOut">
              <a:rPr lang="en-GB" smtClean="0"/>
              <a:t>28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6C5194-9B72-F9E8-D8D6-B42A840D1D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BEC575-FCB7-A5F8-8CF5-FAEFD66C3B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CF57C-8BFD-45D9-A464-2FD639ACAE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41709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528B2E-7626-F289-E9DD-DEEC44BDB5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5640C2-EC25-585D-F676-461C4D203EC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6A99E7-A2DC-DB71-C514-1269BA34A6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8E381-F2BA-4A1F-AD30-CA17B4A5A7D3}" type="datetimeFigureOut">
              <a:rPr lang="en-GB" smtClean="0"/>
              <a:t>28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E83940-AA94-E9F3-E81D-9CEA69775B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73F129-A514-3504-315A-434975043A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CF57C-8BFD-45D9-A464-2FD639ACAE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47453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88EC61-9E92-9097-B4B9-EBBFD008EA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6106CFA-7AB6-2425-63DF-97B988E162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82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82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6A8D19-5423-2378-E0A8-65C455BBCF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8E381-F2BA-4A1F-AD30-CA17B4A5A7D3}" type="datetimeFigureOut">
              <a:rPr lang="en-GB" smtClean="0"/>
              <a:t>28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D0B0F7-95DF-23A7-80FE-CC6747800C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A14748-160F-0FC5-BB33-5958E001C2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CF57C-8BFD-45D9-A464-2FD639ACAE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28715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B9EAFB-893B-C208-DAC2-0B50B8E65F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57A614-2BCA-3718-27E1-563A02315E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7D3D6C2-53E9-D640-F523-F99EAF90C0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3BE5F1-96EC-2EE2-14EC-1D41ECDCD7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8E381-F2BA-4A1F-AD30-CA17B4A5A7D3}" type="datetimeFigureOut">
              <a:rPr lang="en-GB" smtClean="0"/>
              <a:t>28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DC7C53-9D0E-2FBD-E376-449241A9BC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D227B6-E41F-CD9F-E0F9-82D809E387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CF57C-8BFD-45D9-A464-2FD639ACAE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0755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50F441-BF58-9F4D-064C-C4BC88A60D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D98F2FC-A36C-3B8E-BC16-A141AF897C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AA8F508-5627-B455-A885-594305D3DC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711881A-8518-B46B-4646-3451223A6B5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0D054FF-FE3A-23EF-AC38-BC608095780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ACE830C-E07C-A923-B2B4-FBEF9E212A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8E381-F2BA-4A1F-AD30-CA17B4A5A7D3}" type="datetimeFigureOut">
              <a:rPr lang="en-GB" smtClean="0"/>
              <a:t>28/05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159DF6D-C014-3DE8-8EE6-BDCEAA8D47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C8FE852-D5AE-84F9-D89B-39057996E5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CF57C-8BFD-45D9-A464-2FD639ACAE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47819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0BD9CA-B4B7-9217-9F4A-DC0A4A55B4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7587FF2-1CCF-D5F6-FD4C-F9FCA17868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8E381-F2BA-4A1F-AD30-CA17B4A5A7D3}" type="datetimeFigureOut">
              <a:rPr lang="en-GB" smtClean="0"/>
              <a:t>28/05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B3B75CF-572B-7CCB-65FC-167D1D9925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12161DA-E6BB-31C5-F082-77FAB44D8F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CF57C-8BFD-45D9-A464-2FD639ACAE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60444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7707870-C760-860F-B783-5116BE51D1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8E381-F2BA-4A1F-AD30-CA17B4A5A7D3}" type="datetimeFigureOut">
              <a:rPr lang="en-GB" smtClean="0"/>
              <a:t>28/05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83BE287-32C9-B852-2DC2-61BE6C750C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E78A5F0-CAF7-10D3-9020-7C678685E1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CF57C-8BFD-45D9-A464-2FD639ACAE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25699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A5EEAB-2138-0A64-E630-658D2CF9B0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B3AB3F-E32D-8C7F-A8E6-F8354474394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0256DD6-EAF8-5907-20FE-FC628195DB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3D4DF4C-910A-B6A7-4392-FFB57F9475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8E381-F2BA-4A1F-AD30-CA17B4A5A7D3}" type="datetimeFigureOut">
              <a:rPr lang="en-GB" smtClean="0"/>
              <a:t>28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0706602-A58B-07CD-CF21-A1C9C72A38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35F52D-4AB3-20C7-A190-79CE0A6CF1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CF57C-8BFD-45D9-A464-2FD639ACAE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815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CF1304-611E-C64F-E07F-9322BC6452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7D278A9-F44C-76C2-105C-52D28E3F244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54F24F1-3DD4-0C28-F531-47BDA23FE8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18A393-EC1C-4972-168B-224F4624BE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8E381-F2BA-4A1F-AD30-CA17B4A5A7D3}" type="datetimeFigureOut">
              <a:rPr lang="en-GB" smtClean="0"/>
              <a:t>28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7183A8-995C-CB0D-A2DB-42050CAE9C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767E5B-5518-4FE1-9C78-449F827FFF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CF57C-8BFD-45D9-A464-2FD639ACAE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970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DB9FB0B-0856-647D-2EA9-92CE6A7235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3C559C-276D-6EF3-5592-9D53B532B2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D3AC4F-D15A-9BF2-6BA1-CD60B64D2FE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168E381-F2BA-4A1F-AD30-CA17B4A5A7D3}" type="datetimeFigureOut">
              <a:rPr lang="en-GB" smtClean="0"/>
              <a:t>28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6445CD-4175-9F5C-D6CE-DC64706B4A4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982EBF-1CEC-B3B3-E927-96BD839D200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EACF57C-8BFD-45D9-A464-2FD639ACAE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88511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5E5ED01-5386-530E-E247-140AAFFDCB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767" y="1443437"/>
            <a:ext cx="6712465" cy="3509563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C3F0E27-43AF-BEC6-5883-785FB4674856}"/>
              </a:ext>
            </a:extLst>
          </p:cNvPr>
          <p:cNvSpPr txBox="1"/>
          <p:nvPr/>
        </p:nvSpPr>
        <p:spPr>
          <a:xfrm>
            <a:off x="563526" y="808074"/>
            <a:ext cx="12014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11041710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Box 1">
            <a:extLst>
              <a:ext uri="{FF2B5EF4-FFF2-40B4-BE49-F238E27FC236}">
                <a16:creationId xmlns:a16="http://schemas.microsoft.com/office/drawing/2014/main" id="{23574881-99F9-82DB-B82F-29A38BDB5005}"/>
              </a:ext>
            </a:extLst>
          </p:cNvPr>
          <p:cNvSpPr txBox="1"/>
          <p:nvPr/>
        </p:nvSpPr>
        <p:spPr>
          <a:xfrm>
            <a:off x="3260464" y="0"/>
            <a:ext cx="612289" cy="627119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3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GB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A25D65C-59BF-6E53-0A6A-C3182533736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738" y="627119"/>
            <a:ext cx="6285452" cy="920818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5950309-95E2-3969-B177-D34C46572CAD}"/>
              </a:ext>
            </a:extLst>
          </p:cNvPr>
          <p:cNvSpPr txBox="1"/>
          <p:nvPr/>
        </p:nvSpPr>
        <p:spPr>
          <a:xfrm>
            <a:off x="329609" y="128893"/>
            <a:ext cx="12014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14535746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Box 1">
            <a:extLst>
              <a:ext uri="{FF2B5EF4-FFF2-40B4-BE49-F238E27FC236}">
                <a16:creationId xmlns:a16="http://schemas.microsoft.com/office/drawing/2014/main" id="{E921AC2E-93B5-FAFA-E2BE-C015B0DCB951}"/>
              </a:ext>
            </a:extLst>
          </p:cNvPr>
          <p:cNvSpPr txBox="1"/>
          <p:nvPr/>
        </p:nvSpPr>
        <p:spPr>
          <a:xfrm>
            <a:off x="3210878" y="-11747"/>
            <a:ext cx="556260" cy="612140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36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DF0D9F44-171F-0A79-4BC0-0C12E60B835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143" y="469764"/>
            <a:ext cx="6351469" cy="92025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18737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Box 1">
            <a:extLst>
              <a:ext uri="{FF2B5EF4-FFF2-40B4-BE49-F238E27FC236}">
                <a16:creationId xmlns:a16="http://schemas.microsoft.com/office/drawing/2014/main" id="{BBE5BBE0-1CDF-4279-DAEA-5026D5735DFE}"/>
              </a:ext>
            </a:extLst>
          </p:cNvPr>
          <p:cNvSpPr txBox="1"/>
          <p:nvPr/>
        </p:nvSpPr>
        <p:spPr>
          <a:xfrm>
            <a:off x="3150870" y="22860"/>
            <a:ext cx="556260" cy="612140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3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endParaRPr lang="en-GB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53633F6-D04A-F370-42AF-0E65097830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4502" y="635000"/>
            <a:ext cx="6488540" cy="69950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67646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5D6C2884-9043-7F82-CFD3-CCB75C02F8E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15753555"/>
              </p:ext>
            </p:extLst>
          </p:nvPr>
        </p:nvGraphicFramePr>
        <p:xfrm>
          <a:off x="146957" y="263114"/>
          <a:ext cx="7001249" cy="647514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8144109" imgH="7531106" progId="Prism9.Document">
                  <p:embed/>
                </p:oleObj>
              </mc:Choice>
              <mc:Fallback>
                <p:oleObj name="Prism 9" r:id="rId2" imgW="8144109" imgH="753110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46957" y="263114"/>
                        <a:ext cx="7001249" cy="647514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100B2A2F-8033-2655-1127-1CC4E58BB7C4}"/>
              </a:ext>
            </a:extLst>
          </p:cNvPr>
          <p:cNvSpPr txBox="1"/>
          <p:nvPr/>
        </p:nvSpPr>
        <p:spPr>
          <a:xfrm>
            <a:off x="329609" y="128893"/>
            <a:ext cx="12014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245773756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6EEF29E5-DB35-7711-0DBD-2C92FAD7357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43695986"/>
              </p:ext>
            </p:extLst>
          </p:nvPr>
        </p:nvGraphicFramePr>
        <p:xfrm>
          <a:off x="160388" y="491671"/>
          <a:ext cx="6537223" cy="82348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6272124" imgH="7901594" progId="Prism9.Document">
                  <p:embed/>
                </p:oleObj>
              </mc:Choice>
              <mc:Fallback>
                <p:oleObj name="Prism 9" r:id="rId2" imgW="6272124" imgH="7901594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60388" y="491671"/>
                        <a:ext cx="6537223" cy="82348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9557E737-D307-2FCB-5826-3268FAAB4E2D}"/>
              </a:ext>
            </a:extLst>
          </p:cNvPr>
          <p:cNvSpPr txBox="1"/>
          <p:nvPr/>
        </p:nvSpPr>
        <p:spPr>
          <a:xfrm>
            <a:off x="329609" y="128893"/>
            <a:ext cx="12014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igure S4</a:t>
            </a:r>
          </a:p>
        </p:txBody>
      </p:sp>
    </p:spTree>
    <p:extLst>
      <p:ext uri="{BB962C8B-B14F-4D97-AF65-F5344CB8AC3E}">
        <p14:creationId xmlns:p14="http://schemas.microsoft.com/office/powerpoint/2010/main" val="395485103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09DD2010-CEA2-70F7-4921-6E4E8422F00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9679781"/>
              </p:ext>
            </p:extLst>
          </p:nvPr>
        </p:nvGraphicFramePr>
        <p:xfrm>
          <a:off x="0" y="435356"/>
          <a:ext cx="6503146" cy="9035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4750550" imgH="6598742" progId="Prism9.Document">
                  <p:embed/>
                </p:oleObj>
              </mc:Choice>
              <mc:Fallback>
                <p:oleObj name="Prism 9" r:id="rId2" imgW="4750550" imgH="659874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0" y="435356"/>
                        <a:ext cx="6503146" cy="9035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58649691-4614-A646-20E2-8EC65AA38F44}"/>
              </a:ext>
            </a:extLst>
          </p:cNvPr>
          <p:cNvSpPr txBox="1"/>
          <p:nvPr/>
        </p:nvSpPr>
        <p:spPr>
          <a:xfrm>
            <a:off x="329609" y="128893"/>
            <a:ext cx="12014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igure S5</a:t>
            </a:r>
          </a:p>
        </p:txBody>
      </p:sp>
    </p:spTree>
    <p:extLst>
      <p:ext uri="{BB962C8B-B14F-4D97-AF65-F5344CB8AC3E}">
        <p14:creationId xmlns:p14="http://schemas.microsoft.com/office/powerpoint/2010/main" val="53876597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FABAF669-3ED5-DB09-5960-7588B4F88F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4812" y="2366682"/>
            <a:ext cx="6601283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FF4CB209-6834-0EBA-2666-F0E553EACC3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26101318"/>
              </p:ext>
            </p:extLst>
          </p:nvPr>
        </p:nvGraphicFramePr>
        <p:xfrm>
          <a:off x="81905" y="1241612"/>
          <a:ext cx="6874070" cy="37113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9296903" imgH="5026670" progId="Prism9.Document">
                  <p:embed/>
                </p:oleObj>
              </mc:Choice>
              <mc:Fallback>
                <p:oleObj name="Prism 9" r:id="rId2" imgW="9296903" imgH="5026670" progId="Prism9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1905" y="1241612"/>
                        <a:ext cx="6874070" cy="3711388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AB27D376-C9A7-D77B-8B66-51AC96487CE7}"/>
              </a:ext>
            </a:extLst>
          </p:cNvPr>
          <p:cNvSpPr txBox="1"/>
          <p:nvPr/>
        </p:nvSpPr>
        <p:spPr>
          <a:xfrm>
            <a:off x="329609" y="128893"/>
            <a:ext cx="12014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igure S6</a:t>
            </a:r>
          </a:p>
        </p:txBody>
      </p:sp>
    </p:spTree>
    <p:extLst>
      <p:ext uri="{BB962C8B-B14F-4D97-AF65-F5344CB8AC3E}">
        <p14:creationId xmlns:p14="http://schemas.microsoft.com/office/powerpoint/2010/main" val="33093100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43</TotalTime>
  <Words>15</Words>
  <Application>Microsoft Office PowerPoint</Application>
  <PresentationFormat>A4 Paper (210x297 mm)</PresentationFormat>
  <Paragraphs>9</Paragraphs>
  <Slides>8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5" baseType="lpstr">
      <vt:lpstr>Aptos</vt:lpstr>
      <vt:lpstr>Aptos Display</vt:lpstr>
      <vt:lpstr>Arial</vt:lpstr>
      <vt:lpstr>Calibri</vt:lpstr>
      <vt:lpstr>Times New Roman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ngh Parvind</dc:creator>
  <cp:lastModifiedBy>MDPI</cp:lastModifiedBy>
  <cp:revision>20</cp:revision>
  <dcterms:created xsi:type="dcterms:W3CDTF">2024-03-17T16:57:24Z</dcterms:created>
  <dcterms:modified xsi:type="dcterms:W3CDTF">2024-05-28T13:02:45Z</dcterms:modified>
</cp:coreProperties>
</file>